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5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C38B7E-2D4F-A24F-9EB9-E1297593CA9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4153C8-C015-7D4F-8C76-FA12983EF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01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1E53B9-108B-0040-BC42-249C7F3D281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158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1AFB3-FBE8-769A-B1AA-400343EE65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008255-84C3-946C-D417-93F7EE9B4C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C27C4-12F8-CDE8-50FD-BE24866DB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38492-EEF7-9D5C-C1B2-AEA9C679E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8B217-4252-DA62-5F95-FD9581585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424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8A02E-72B5-5E12-8A25-296AE9AC2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11503B-7808-C627-A110-03EE96631F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309DB-5D73-0596-9A16-8856854AA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FD8C62-0B5F-00ED-08FC-8E348B79E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3F36B6-A85F-1518-6C7C-CDC742632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366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C16A69-A1BB-9565-9F63-819620FEF7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CEB081-2E5F-AA42-81D6-0F9A26B597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26008-969D-4799-BBD2-6427119EA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60D84-3685-B46D-7D5C-605C8FC03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5A8E95-BE4C-3E22-1088-45B0A9F3F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646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CD8B6-C6B5-BAB7-D1DF-42CE4FBCC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43635B-365F-5972-4EE7-005550D62F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9AADAD-9F24-2C91-E9C7-BC18FB44E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4332B-F37F-244E-F47C-F2E221602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57A54-6068-ACEC-5B27-08D677A0C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291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CFFF5C-A831-789D-EE53-BC4473467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7BFFBD-ED1B-B21C-0EDA-52D32E0E6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066F4E-7730-0A39-41F8-FF2C7EFCC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816EF-4FD5-DB85-52D2-7263F5F0D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87219-9588-2475-5C02-682B98C29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758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C8E90-19EA-61D9-F7BE-743AF027F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CC266D-D5E3-70A5-DD5D-8C458F6FAB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6C97B6-3D86-4804-B5B7-F5DCE942F1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398CDC-76F1-9360-61F6-1DCCB1183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FF956D-E793-591E-FB81-87269E76B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AD6B6B-9068-3A93-1D67-5F008F987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48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6BBFE-DFEC-25F1-92B8-95A83177E9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685631-ACCC-B087-E125-C43F565203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D092E4-17F9-973F-AFE9-CC17FAFFB2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8AE5-0087-B2CA-5D59-24A9AB6D4F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5D9228-BCD6-FD5C-8E64-0A617A98B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6894CB-E434-901D-317F-9B2B552F7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AFAB8D-1D6F-4E69-961A-3D5D22C27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29DE0C-820E-504D-E7A3-3CF1F060C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848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488A8-BDD5-40E3-B854-1BD7501030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0F63D7A-D0A6-302E-310B-F66B1A9F1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95DD49-D5E1-F6A0-649A-AA95C156F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81E79-4A7B-A345-965F-0E8CC5DE4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699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211976-A14A-6409-EEF2-0BA709DBA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C6838F-3792-A3FF-20FE-0A67B5C62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1A6ED7-D18B-7C4A-BA3D-47B16724E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13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3C564-2FDF-1A8B-C04A-B1C5F88FD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4FAA8C-D743-8716-97F0-0C2215D254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43B886-B1DF-1393-8F83-A20E996B43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563C49-1855-01E7-5278-DC6FCDD147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9AABED-30D4-578F-A8F1-59E2BCDBF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FCE3BF-C782-B0C4-782D-9AF9CAEAB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364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045EFD-75EB-8B98-1E0B-7A6596493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96D7E8-EEDB-EC2F-65B9-48532C3236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9D732F-A8CE-3947-7D3B-8B5EB5ACEC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30361B-EC96-7456-3261-27703DC1F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9E9408-49AF-CE37-6A8A-B489BFDDC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B6BD76-F79E-2AB6-A79C-C5F617233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885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03E434-DD89-A0CF-1631-29D147868A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964232-E6CA-9F35-EFD4-B209F0004F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40A538-BFFF-AFCB-44BA-BD25F2D2E4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200D35-7188-9D43-8CEB-89A5B034C400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1CC34-9E07-1CEC-589C-A06DBFC05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B5B752-2D81-25C7-3095-9DE9A70A32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FF65CC-33BF-1244-9962-D318502CFE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6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76C0D0-EF95-5388-869B-B66AFC7258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FF052A1-CF26-9DE9-D67B-600D9332C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119DEE-6564-744F-ADC0-8DE76370C9CC}" type="slidenum">
              <a:rPr lang="en-US" smtClean="0"/>
              <a:t>1</a:t>
            </a:fld>
            <a:endParaRPr lang="en-US"/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5CEE47FC-3A31-7574-5BC7-920BA7C310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0" y="1088542"/>
            <a:ext cx="6100444" cy="4880355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D6E88C7D-7B80-E30D-E850-BE70EA99C38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6140195" y="1088542"/>
            <a:ext cx="5999165" cy="479933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B0B60C3-E073-5095-9AE9-063AF264C7BF}"/>
              </a:ext>
            </a:extLst>
          </p:cNvPr>
          <p:cNvSpPr txBox="1"/>
          <p:nvPr/>
        </p:nvSpPr>
        <p:spPr>
          <a:xfrm>
            <a:off x="52640" y="71921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D81D48-A078-F4A3-2721-108484644CBE}"/>
              </a:ext>
            </a:extLst>
          </p:cNvPr>
          <p:cNvSpPr txBox="1"/>
          <p:nvPr/>
        </p:nvSpPr>
        <p:spPr>
          <a:xfrm>
            <a:off x="6140195" y="719210"/>
            <a:ext cx="39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9C3D528-8837-001D-132D-AE97003FF9A8}"/>
              </a:ext>
            </a:extLst>
          </p:cNvPr>
          <p:cNvSpPr txBox="1"/>
          <p:nvPr/>
        </p:nvSpPr>
        <p:spPr>
          <a:xfrm>
            <a:off x="312775" y="6257206"/>
            <a:ext cx="118792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1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Forest plot for covariates for </a:t>
            </a: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verall survival (OS) and </a:t>
            </a: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gression free survival (PFS) (109 patients)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92072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5</Words>
  <Application>Microsoft Macintosh PowerPoint</Application>
  <PresentationFormat>Widescreen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2</cp:revision>
  <dcterms:created xsi:type="dcterms:W3CDTF">2025-08-22T16:45:54Z</dcterms:created>
  <dcterms:modified xsi:type="dcterms:W3CDTF">2025-10-28T19:06:10Z</dcterms:modified>
</cp:coreProperties>
</file>